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37" r:id="rId2"/>
    <p:sldId id="342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9" autoAdjust="0"/>
    <p:restoredTop sz="94660"/>
  </p:normalViewPr>
  <p:slideViewPr>
    <p:cSldViewPr snapToGrid="0">
      <p:cViewPr varScale="1">
        <p:scale>
          <a:sx n="138" d="100"/>
          <a:sy n="138" d="100"/>
        </p:scale>
        <p:origin x="192" y="7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605E875-1F50-4C7E-B0A5-8FEA3FD9891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C3930C54-18AB-4AC3-876F-0FDD3F093AD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617BC69-B855-453C-82EB-637C34DA05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FADEF-D050-419C-97C3-DD13FBD9346F}" type="datetimeFigureOut">
              <a:rPr kumimoji="1" lang="ja-JP" altLang="en-US" smtClean="0"/>
              <a:t>2019/4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8589376-BFEC-4997-95E4-B70D9B5310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E83B6A8-9A74-4A96-B568-DC0792BCE0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E1C40-15F3-45D2-8C4F-98C8BEF0D4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05520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7FAD4C0-8602-43D6-93F5-7B1E29A164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C7DC86F-015C-4102-9EA7-00A0F9A1F7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F79F685-8264-4302-8B4A-E5927B5676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FADEF-D050-419C-97C3-DD13FBD9346F}" type="datetimeFigureOut">
              <a:rPr kumimoji="1" lang="ja-JP" altLang="en-US" smtClean="0"/>
              <a:t>2019/4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34DC9A8-5AAE-4E81-9094-A0E3CE56FB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883B586-3DC0-4041-9B53-3B212EF0FB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E1C40-15F3-45D2-8C4F-98C8BEF0D4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29297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81A49881-1A4B-4FC4-B65F-4C8D49E2D3E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870C357-5066-4404-B3E7-29E412FCDF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85BC35F-2794-4A29-9C22-EE3B5530AE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FADEF-D050-419C-97C3-DD13FBD9346F}" type="datetimeFigureOut">
              <a:rPr kumimoji="1" lang="ja-JP" altLang="en-US" smtClean="0"/>
              <a:t>2019/4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DC54448-C244-44EC-9A8D-36D0476D23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1807E69-7603-496B-B3A5-15F69F706E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E1C40-15F3-45D2-8C4F-98C8BEF0D4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896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E7FEF90-1F66-47F6-AB2E-3A1C76CFAF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080ECD1-D6C8-47D5-ADA4-F5E375DE2D7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3FEF444-D792-4A08-BF50-E103DB177F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FADEF-D050-419C-97C3-DD13FBD9346F}" type="datetimeFigureOut">
              <a:rPr kumimoji="1" lang="ja-JP" altLang="en-US" smtClean="0"/>
              <a:t>2019/4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15ADDEA-78BC-4365-9F5E-E89DA72448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5881D75-3024-4FEE-BD4F-08077B0E30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E1C40-15F3-45D2-8C4F-98C8BEF0D4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82508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E440555-8244-44B9-81C7-86FBFA9E18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1D81B39-6413-4A07-B1E6-68FA56B20D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2A4ABC0-FD99-4EFE-BFE2-EF282005BE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FADEF-D050-419C-97C3-DD13FBD9346F}" type="datetimeFigureOut">
              <a:rPr kumimoji="1" lang="ja-JP" altLang="en-US" smtClean="0"/>
              <a:t>2019/4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F08A2A4-AD3A-4195-ACE0-9CA86BCF2D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EEC8618-2074-4003-BB74-6CA48A35BE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E1C40-15F3-45D2-8C4F-98C8BEF0D4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15096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82892BF-5BF4-47D1-9B21-8201EF8975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DC4D8F8-2127-43B8-9318-79F8BCA43A3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9943E50-EEB3-45E4-A5F3-CD0B1B31C1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02D48C0-2D94-482A-9CDD-1D814AFD4D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FADEF-D050-419C-97C3-DD13FBD9346F}" type="datetimeFigureOut">
              <a:rPr kumimoji="1" lang="ja-JP" altLang="en-US" smtClean="0"/>
              <a:t>2019/4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2F90523-CBC5-4514-AB2A-93980546B4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262E6C1-5690-439F-B738-62F7AEAB0B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E1C40-15F3-45D2-8C4F-98C8BEF0D4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33020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EF1048B-A038-45A1-869C-D18C373C6F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EC011BE-A03C-4A05-8EA9-B69373BA3D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3C614A7-8900-4FA6-89E9-F639179898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5760ACC-EB03-4381-A012-B657431DF0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42B3A50-10FF-442F-8F24-9E52C80D92A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0D14EC36-1D32-413E-B045-DB474618B3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FADEF-D050-419C-97C3-DD13FBD9346F}" type="datetimeFigureOut">
              <a:rPr kumimoji="1" lang="ja-JP" altLang="en-US" smtClean="0"/>
              <a:t>2019/4/1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6739A978-2104-43AC-94BF-F272CC0FA2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0EB792B-5522-46D6-A370-31B2C67B3A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E1C40-15F3-45D2-8C4F-98C8BEF0D4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44785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FCB2205-7741-4128-9B05-C93E863DAB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953FFD1-89D8-4841-A17E-D3E8D73643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FADEF-D050-419C-97C3-DD13FBD9346F}" type="datetimeFigureOut">
              <a:rPr kumimoji="1" lang="ja-JP" altLang="en-US" smtClean="0"/>
              <a:t>2019/4/1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3990F53B-77BD-460D-9A3E-CF6F67BA63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4F72803C-EDE4-4D91-A85F-6E5F5133A6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E1C40-15F3-45D2-8C4F-98C8BEF0D4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82164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771BC70-6DF6-4836-8BD3-B6A048B1DD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FADEF-D050-419C-97C3-DD13FBD9346F}" type="datetimeFigureOut">
              <a:rPr kumimoji="1" lang="ja-JP" altLang="en-US" smtClean="0"/>
              <a:t>2019/4/1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36BE772A-D4CB-40C5-8DB7-65FF675189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19951E03-7877-4781-A835-991820AE71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E1C40-15F3-45D2-8C4F-98C8BEF0D4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53524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8D7F950-F6CC-417D-94A8-50EB284D8E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D34175B-7BA6-4F39-B0BE-6835D78F93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BA78176-A5A7-411F-A7E4-7208B29A17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4F11D14-CE72-470D-A9A9-9B3AD7D946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FADEF-D050-419C-97C3-DD13FBD9346F}" type="datetimeFigureOut">
              <a:rPr kumimoji="1" lang="ja-JP" altLang="en-US" smtClean="0"/>
              <a:t>2019/4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A31F535-6924-4604-ABB1-E14A61BD03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98F1DCB-7056-49EA-A615-C2F36DAAE0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E1C40-15F3-45D2-8C4F-98C8BEF0D4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34848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B523DC4-82D1-4059-BC4A-23A57D6B29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CB6CC14F-0A79-450F-A3DC-CB94DAF97BE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8A5F23D-0169-4EA7-BE8D-B7A69D638A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80E983C-B9E3-4A10-9039-5C28B416F3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FADEF-D050-419C-97C3-DD13FBD9346F}" type="datetimeFigureOut">
              <a:rPr kumimoji="1" lang="ja-JP" altLang="en-US" smtClean="0"/>
              <a:t>2019/4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6139B5A-7782-4806-89AB-14906A624E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D135C4C-88FD-4D90-A1C1-4D6BFA65E4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AE1C40-15F3-45D2-8C4F-98C8BEF0D4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05209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198EAD3D-659D-4A5B-BE16-0331DDA5C9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936D31A-96AB-438D-83AF-C946297559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071649A-B0E7-4655-9C16-2E7E015EB52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0FADEF-D050-419C-97C3-DD13FBD9346F}" type="datetimeFigureOut">
              <a:rPr kumimoji="1" lang="ja-JP" altLang="en-US" smtClean="0"/>
              <a:t>2019/4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AD1CD5F-EC1E-4250-9B28-4E2B4555FFE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E607D40-53D0-4DD8-BE5A-5055EAF347B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AE1C40-15F3-45D2-8C4F-98C8BEF0D4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8454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9423FD1-BF9A-42FB-B128-0B345BE7B4A7}"/>
              </a:ext>
            </a:extLst>
          </p:cNvPr>
          <p:cNvSpPr txBox="1"/>
          <p:nvPr/>
        </p:nvSpPr>
        <p:spPr>
          <a:xfrm>
            <a:off x="4926677" y="628205"/>
            <a:ext cx="28184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Sample 1 : Tumor</a:t>
            </a:r>
            <a:endParaRPr kumimoji="1" lang="ja-JP" altLang="en-US" sz="2400" b="1" dirty="0"/>
          </a:p>
        </p:txBody>
      </p:sp>
      <p:sp>
        <p:nvSpPr>
          <p:cNvPr id="5" name="矢印: 下 4">
            <a:extLst>
              <a:ext uri="{FF2B5EF4-FFF2-40B4-BE49-F238E27FC236}">
                <a16:creationId xmlns:a16="http://schemas.microsoft.com/office/drawing/2014/main" id="{FABA63AC-04E3-4BBA-84ED-1F80B91B14B3}"/>
              </a:ext>
            </a:extLst>
          </p:cNvPr>
          <p:cNvSpPr/>
          <p:nvPr/>
        </p:nvSpPr>
        <p:spPr>
          <a:xfrm rot="7196311">
            <a:off x="1347747" y="5569888"/>
            <a:ext cx="290222" cy="329979"/>
          </a:xfrm>
          <a:prstGeom prst="down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74F5B1C7-9F48-453E-AB27-4DD7A32AE1E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490" t="27015" r="46359" b="25932"/>
          <a:stretch/>
        </p:blipFill>
        <p:spPr>
          <a:xfrm>
            <a:off x="588395" y="1470992"/>
            <a:ext cx="6368691" cy="4795221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73330500-C7BD-4BA2-B7F8-BDE2E2E7748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9435" t="40390" r="65369" b="33565"/>
          <a:stretch/>
        </p:blipFill>
        <p:spPr>
          <a:xfrm>
            <a:off x="7386762" y="2323605"/>
            <a:ext cx="3430988" cy="3307838"/>
          </a:xfrm>
          <a:prstGeom prst="rect">
            <a:avLst/>
          </a:prstGeom>
        </p:spPr>
      </p:pic>
      <p:sp>
        <p:nvSpPr>
          <p:cNvPr id="8" name="矢印: 右 7">
            <a:extLst>
              <a:ext uri="{FF2B5EF4-FFF2-40B4-BE49-F238E27FC236}">
                <a16:creationId xmlns:a16="http://schemas.microsoft.com/office/drawing/2014/main" id="{3C28BC46-1BD4-4C33-9725-066E09CB06E4}"/>
              </a:ext>
            </a:extLst>
          </p:cNvPr>
          <p:cNvSpPr/>
          <p:nvPr/>
        </p:nvSpPr>
        <p:spPr>
          <a:xfrm rot="10800000">
            <a:off x="6776194" y="4005470"/>
            <a:ext cx="361784" cy="306125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矢印: 右 8">
            <a:extLst>
              <a:ext uri="{FF2B5EF4-FFF2-40B4-BE49-F238E27FC236}">
                <a16:creationId xmlns:a16="http://schemas.microsoft.com/office/drawing/2014/main" id="{8459FB28-5705-4331-BFA2-8B3F9A0840F8}"/>
              </a:ext>
            </a:extLst>
          </p:cNvPr>
          <p:cNvSpPr/>
          <p:nvPr/>
        </p:nvSpPr>
        <p:spPr>
          <a:xfrm rot="10800000">
            <a:off x="10704750" y="4005470"/>
            <a:ext cx="361784" cy="306125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1A83D1C-2974-4A53-BD67-56C721351AE7}"/>
              </a:ext>
            </a:extLst>
          </p:cNvPr>
          <p:cNvSpPr txBox="1"/>
          <p:nvPr/>
        </p:nvSpPr>
        <p:spPr>
          <a:xfrm>
            <a:off x="8815912" y="1954273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Result</a:t>
            </a:r>
            <a:endParaRPr kumimoji="1" lang="ja-JP" altLang="en-US" b="1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BBBFF0A-9601-4102-B2B0-53E7C7BFD00E}"/>
              </a:ext>
            </a:extLst>
          </p:cNvPr>
          <p:cNvSpPr txBox="1"/>
          <p:nvPr/>
        </p:nvSpPr>
        <p:spPr>
          <a:xfrm>
            <a:off x="9915503" y="2433254"/>
            <a:ext cx="677287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000" b="1" dirty="0"/>
              <a:t>Number</a:t>
            </a:r>
            <a:r>
              <a:rPr lang="ja-JP" altLang="en-US" sz="1000" b="1" dirty="0"/>
              <a:t> </a:t>
            </a:r>
            <a:endParaRPr lang="en-US" altLang="ja-JP" sz="1000" b="1" dirty="0"/>
          </a:p>
          <a:p>
            <a:r>
              <a:rPr lang="en-US" altLang="ja-JP" sz="1000" b="1" dirty="0"/>
              <a:t>of</a:t>
            </a:r>
            <a:r>
              <a:rPr lang="ja-JP" altLang="en-US" sz="1000" b="1" dirty="0"/>
              <a:t> </a:t>
            </a:r>
            <a:r>
              <a:rPr lang="en-US" altLang="ja-JP" sz="1000" b="1" dirty="0"/>
              <a:t>cells</a:t>
            </a:r>
            <a:endParaRPr kumimoji="1" lang="ja-JP" altLang="en-US" sz="1000" b="1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DD10F86-4BB1-4201-93CE-966FCD8829E7}"/>
              </a:ext>
            </a:extLst>
          </p:cNvPr>
          <p:cNvSpPr txBox="1"/>
          <p:nvPr/>
        </p:nvSpPr>
        <p:spPr>
          <a:xfrm>
            <a:off x="8035258" y="2433254"/>
            <a:ext cx="724773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000" b="1" dirty="0"/>
              <a:t>Signal pattern</a:t>
            </a:r>
            <a:endParaRPr kumimoji="1" lang="ja-JP" altLang="en-US" sz="1000" b="1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B5EC9BC-AB0B-4A65-A2CC-8EA62F788305}"/>
              </a:ext>
            </a:extLst>
          </p:cNvPr>
          <p:cNvSpPr txBox="1"/>
          <p:nvPr/>
        </p:nvSpPr>
        <p:spPr>
          <a:xfrm>
            <a:off x="8879248" y="2394114"/>
            <a:ext cx="977272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700" b="1" dirty="0"/>
              <a:t>Number of Signal</a:t>
            </a:r>
            <a:endParaRPr kumimoji="1" lang="ja-JP" altLang="en-US" sz="700" b="1" dirty="0"/>
          </a:p>
        </p:txBody>
      </p:sp>
    </p:spTree>
    <p:extLst>
      <p:ext uri="{BB962C8B-B14F-4D97-AF65-F5344CB8AC3E}">
        <p14:creationId xmlns:p14="http://schemas.microsoft.com/office/powerpoint/2010/main" val="33269221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C7CA3F78-32E3-47A9-BA88-9B9C11BFE3F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1980" t="23419" r="31591" b="29505"/>
          <a:stretch/>
        </p:blipFill>
        <p:spPr>
          <a:xfrm>
            <a:off x="566055" y="1967344"/>
            <a:ext cx="5847483" cy="4250575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83A8F0D-8126-4637-BC67-E33B0B261914}"/>
              </a:ext>
            </a:extLst>
          </p:cNvPr>
          <p:cNvSpPr txBox="1"/>
          <p:nvPr/>
        </p:nvSpPr>
        <p:spPr>
          <a:xfrm>
            <a:off x="5004337" y="618850"/>
            <a:ext cx="28184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/>
              <a:t>Sample 6 : Tumor</a:t>
            </a:r>
            <a:endParaRPr kumimoji="1" lang="ja-JP" altLang="en-US" sz="2400" b="1" dirty="0"/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394DB83D-2E5E-42A5-B973-710C7DB85EC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8570" t="41274" r="30715" b="45570"/>
          <a:stretch/>
        </p:blipFill>
        <p:spPr>
          <a:xfrm>
            <a:off x="6210795" y="2921330"/>
            <a:ext cx="5786358" cy="2067296"/>
          </a:xfrm>
          <a:prstGeom prst="rect">
            <a:avLst/>
          </a:prstGeom>
        </p:spPr>
      </p:pic>
      <p:sp>
        <p:nvSpPr>
          <p:cNvPr id="6" name="矢印: 下 5">
            <a:extLst>
              <a:ext uri="{FF2B5EF4-FFF2-40B4-BE49-F238E27FC236}">
                <a16:creationId xmlns:a16="http://schemas.microsoft.com/office/drawing/2014/main" id="{F4F31201-34DE-4E95-AEC1-AF173524AE2B}"/>
              </a:ext>
            </a:extLst>
          </p:cNvPr>
          <p:cNvSpPr/>
          <p:nvPr/>
        </p:nvSpPr>
        <p:spPr>
          <a:xfrm>
            <a:off x="10335491" y="2395294"/>
            <a:ext cx="364177" cy="384959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矢印: 下 6">
            <a:extLst>
              <a:ext uri="{FF2B5EF4-FFF2-40B4-BE49-F238E27FC236}">
                <a16:creationId xmlns:a16="http://schemas.microsoft.com/office/drawing/2014/main" id="{BA55C69F-17A0-4B9A-AF14-EC3EE85E5343}"/>
              </a:ext>
            </a:extLst>
          </p:cNvPr>
          <p:cNvSpPr/>
          <p:nvPr/>
        </p:nvSpPr>
        <p:spPr>
          <a:xfrm rot="5400000">
            <a:off x="6231449" y="5401730"/>
            <a:ext cx="364177" cy="384959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913A556-4EA8-4D47-B437-74C8E02DEB33}"/>
              </a:ext>
            </a:extLst>
          </p:cNvPr>
          <p:cNvSpPr txBox="1"/>
          <p:nvPr/>
        </p:nvSpPr>
        <p:spPr>
          <a:xfrm>
            <a:off x="8784244" y="2582767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Result</a:t>
            </a:r>
            <a:endParaRPr kumimoji="1" lang="ja-JP" altLang="en-US" b="1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D69A24F-B56E-41C3-8BDC-ABFFE610C8CD}"/>
              </a:ext>
            </a:extLst>
          </p:cNvPr>
          <p:cNvSpPr txBox="1"/>
          <p:nvPr/>
        </p:nvSpPr>
        <p:spPr>
          <a:xfrm>
            <a:off x="6638379" y="4416433"/>
            <a:ext cx="677287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000" b="1" dirty="0"/>
              <a:t>Number</a:t>
            </a:r>
            <a:r>
              <a:rPr lang="ja-JP" altLang="en-US" sz="1000" b="1" dirty="0"/>
              <a:t> </a:t>
            </a:r>
            <a:endParaRPr lang="en-US" altLang="ja-JP" sz="1000" b="1" dirty="0"/>
          </a:p>
          <a:p>
            <a:r>
              <a:rPr lang="en-US" altLang="ja-JP" sz="1000" b="1" dirty="0"/>
              <a:t>of</a:t>
            </a:r>
            <a:r>
              <a:rPr lang="ja-JP" altLang="en-US" sz="1000" b="1" dirty="0"/>
              <a:t> </a:t>
            </a:r>
            <a:r>
              <a:rPr lang="en-US" altLang="ja-JP" sz="1000" b="1" dirty="0"/>
              <a:t>cells</a:t>
            </a:r>
            <a:endParaRPr kumimoji="1" lang="ja-JP" altLang="en-US" sz="1000" b="1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A281967-34A9-4E71-B1B3-8D1D3D69B021}"/>
              </a:ext>
            </a:extLst>
          </p:cNvPr>
          <p:cNvSpPr txBox="1"/>
          <p:nvPr/>
        </p:nvSpPr>
        <p:spPr>
          <a:xfrm>
            <a:off x="6657720" y="3308069"/>
            <a:ext cx="724773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000" b="1" dirty="0"/>
              <a:t>Signal pattern</a:t>
            </a:r>
            <a:endParaRPr kumimoji="1" lang="ja-JP" altLang="en-US" sz="1000" b="1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A368D5D-896B-4439-A920-32C4D899D761}"/>
              </a:ext>
            </a:extLst>
          </p:cNvPr>
          <p:cNvSpPr txBox="1"/>
          <p:nvPr/>
        </p:nvSpPr>
        <p:spPr>
          <a:xfrm>
            <a:off x="6413537" y="3923354"/>
            <a:ext cx="724773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800" b="1" dirty="0"/>
              <a:t>Number of </a:t>
            </a:r>
          </a:p>
          <a:p>
            <a:r>
              <a:rPr lang="en-US" altLang="ja-JP" sz="800" b="1" dirty="0"/>
              <a:t>Signal</a:t>
            </a:r>
            <a:endParaRPr kumimoji="1" lang="ja-JP" altLang="en-US" sz="800" b="1" dirty="0"/>
          </a:p>
        </p:txBody>
      </p:sp>
    </p:spTree>
    <p:extLst>
      <p:ext uri="{BB962C8B-B14F-4D97-AF65-F5344CB8AC3E}">
        <p14:creationId xmlns:p14="http://schemas.microsoft.com/office/powerpoint/2010/main" val="10028153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26</Words>
  <Application>Microsoft Office PowerPoint</Application>
  <PresentationFormat>ワイド画面</PresentationFormat>
  <Paragraphs>13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nji</dc:creator>
  <cp:lastModifiedBy>Shinji</cp:lastModifiedBy>
  <cp:revision>2</cp:revision>
  <dcterms:created xsi:type="dcterms:W3CDTF">2019-04-19T06:33:43Z</dcterms:created>
  <dcterms:modified xsi:type="dcterms:W3CDTF">2019-04-19T06:44:53Z</dcterms:modified>
</cp:coreProperties>
</file>